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02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32EB284F-7949-FC44-AED4-8C4F679D9722}">
          <p14:sldIdLst>
            <p14:sldId id="302"/>
          </p14:sldIdLst>
        </p14:section>
      </p14:sectionLst>
    </p:ex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7F85FF"/>
    <a:srgbClr val="FC5653"/>
    <a:srgbClr val="FEA0A1"/>
    <a:srgbClr val="FD695A"/>
    <a:srgbClr val="9BADFF"/>
    <a:srgbClr val="495EFF"/>
    <a:srgbClr val="61FF58"/>
    <a:srgbClr val="84FF7D"/>
    <a:srgbClr val="22FF09"/>
    <a:srgbClr val="69CA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067" autoAdjust="0"/>
    <p:restoredTop sz="92475" autoAdjust="0"/>
  </p:normalViewPr>
  <p:slideViewPr>
    <p:cSldViewPr snapToGrid="0" snapToObjects="1">
      <p:cViewPr>
        <p:scale>
          <a:sx n="201" d="100"/>
          <a:sy n="201" d="100"/>
        </p:scale>
        <p:origin x="-760" y="364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Shared:Labs:Rhee:Private:Fan:predict_causual_genes:new_model_tuning:SV_training%20set%20ratio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Shared:Labs:Rhee:Private:Fan:predict_causual_genes:new_model_tuning:SV_training%20set%20ratio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Shared:Labs:Rhee:Private:Fan:predict_causual_genes:new_model_tuning:SV_training%20set%20ratio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Shared:Labs:Rhee:Private:Fan:predict_causual_genes:new_model_tuning:SV_training%20set%20rati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1374643985253"/>
          <c:y val="0.133519554890349"/>
          <c:w val="0.709801522102162"/>
          <c:h val="0.55976052580204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4F81BD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IV training ratio'!$C$6:$C$15</c:f>
                <c:numCache>
                  <c:formatCode>General</c:formatCode>
                  <c:ptCount val="10"/>
                  <c:pt idx="0">
                    <c:v>0.00116803507916151</c:v>
                  </c:pt>
                  <c:pt idx="1">
                    <c:v>0.000438688379064168</c:v>
                  </c:pt>
                  <c:pt idx="2">
                    <c:v>0.000789985136050483</c:v>
                  </c:pt>
                  <c:pt idx="3">
                    <c:v>0.00152706370579809</c:v>
                  </c:pt>
                  <c:pt idx="4">
                    <c:v>0.000919283968867867</c:v>
                  </c:pt>
                  <c:pt idx="5">
                    <c:v>0.000858743340496642</c:v>
                  </c:pt>
                  <c:pt idx="6">
                    <c:v>0.000570393320249942</c:v>
                  </c:pt>
                  <c:pt idx="7">
                    <c:v>0.00164916418954685</c:v>
                  </c:pt>
                  <c:pt idx="8">
                    <c:v>0.00318498634914395</c:v>
                  </c:pt>
                  <c:pt idx="9">
                    <c:v>0.00133585973785732</c:v>
                  </c:pt>
                </c:numCache>
              </c:numRef>
            </c:plus>
            <c:minus>
              <c:numRef>
                <c:f>'SIV training ratio'!$C$6:$C$15</c:f>
                <c:numCache>
                  <c:formatCode>General</c:formatCode>
                  <c:ptCount val="10"/>
                  <c:pt idx="0">
                    <c:v>0.00116803507916151</c:v>
                  </c:pt>
                  <c:pt idx="1">
                    <c:v>0.000438688379064168</c:v>
                  </c:pt>
                  <c:pt idx="2">
                    <c:v>0.000789985136050483</c:v>
                  </c:pt>
                  <c:pt idx="3">
                    <c:v>0.00152706370579809</c:v>
                  </c:pt>
                  <c:pt idx="4">
                    <c:v>0.000919283968867867</c:v>
                  </c:pt>
                  <c:pt idx="5">
                    <c:v>0.000858743340496642</c:v>
                  </c:pt>
                  <c:pt idx="6">
                    <c:v>0.000570393320249942</c:v>
                  </c:pt>
                  <c:pt idx="7">
                    <c:v>0.00164916418954685</c:v>
                  </c:pt>
                  <c:pt idx="8">
                    <c:v>0.00318498634914395</c:v>
                  </c:pt>
                  <c:pt idx="9">
                    <c:v>0.00133585973785732</c:v>
                  </c:pt>
                </c:numCache>
              </c:numRef>
            </c:minus>
          </c:errBars>
          <c:cat>
            <c:strRef>
              <c:f>'SIV training ratio'!$A$6:$A$15</c:f>
              <c:strCache>
                <c:ptCount val="10"/>
                <c:pt idx="0">
                  <c:v>10:1</c:v>
                </c:pt>
                <c:pt idx="1">
                  <c:v>5:1</c:v>
                </c:pt>
                <c:pt idx="2">
                  <c:v>2:1</c:v>
                </c:pt>
                <c:pt idx="3">
                  <c:v>1:1</c:v>
                </c:pt>
                <c:pt idx="4">
                  <c:v>1:2</c:v>
                </c:pt>
                <c:pt idx="5">
                  <c:v>1:5</c:v>
                </c:pt>
                <c:pt idx="6">
                  <c:v>1:10</c:v>
                </c:pt>
                <c:pt idx="7">
                  <c:v>1:20</c:v>
                </c:pt>
                <c:pt idx="8">
                  <c:v>1:50</c:v>
                </c:pt>
                <c:pt idx="9">
                  <c:v>1:100</c:v>
                </c:pt>
              </c:strCache>
            </c:strRef>
          </c:cat>
          <c:val>
            <c:numRef>
              <c:f>'SIV training ratio'!$B$6:$B$15</c:f>
              <c:numCache>
                <c:formatCode>General</c:formatCode>
                <c:ptCount val="10"/>
                <c:pt idx="0">
                  <c:v>0.681569176753249</c:v>
                </c:pt>
                <c:pt idx="1">
                  <c:v>0.711526894164002</c:v>
                </c:pt>
                <c:pt idx="2">
                  <c:v>0.744078229113865</c:v>
                </c:pt>
                <c:pt idx="3">
                  <c:v>0.760609819328728</c:v>
                </c:pt>
                <c:pt idx="4">
                  <c:v>0.769102211488016</c:v>
                </c:pt>
                <c:pt idx="5">
                  <c:v>0.780178057403517</c:v>
                </c:pt>
                <c:pt idx="6">
                  <c:v>0.77786404129579</c:v>
                </c:pt>
                <c:pt idx="7">
                  <c:v>0.777882236511937</c:v>
                </c:pt>
                <c:pt idx="8">
                  <c:v>0.767312699113942</c:v>
                </c:pt>
                <c:pt idx="9">
                  <c:v>0.75505244087337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AEB-2E49-BBE5-8ABCBB8802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0593976"/>
        <c:axId val="-2135472984"/>
      </c:barChart>
      <c:catAx>
        <c:axId val="-21405939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100" b="1" i="0" u="none" strike="noStrike" baseline="0" dirty="0">
                    <a:effectLst/>
                  </a:rPr>
                  <a:t>Ratio of positives and negatives in the training set 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.173764530043279"/>
              <c:y val="0.854390318732614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35472984"/>
        <c:crosses val="autoZero"/>
        <c:auto val="1"/>
        <c:lblAlgn val="ctr"/>
        <c:lblOffset val="100"/>
        <c:noMultiLvlLbl val="0"/>
      </c:catAx>
      <c:valAx>
        <c:axId val="-2135472984"/>
        <c:scaling>
          <c:orientation val="minMax"/>
          <c:min val="0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AUC-ROC</a:t>
                </a:r>
              </a:p>
            </c:rich>
          </c:tx>
          <c:layout>
            <c:manualLayout>
              <c:xMode val="edge"/>
              <c:yMode val="edge"/>
              <c:x val="0.0"/>
              <c:y val="0.27055378408277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40593976"/>
        <c:crosses val="autoZero"/>
        <c:crossBetween val="between"/>
        <c:majorUnit val="0.05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solidFill>
        <a:srgbClr val="FFFFFF"/>
      </a:solidFill>
    </a:ln>
  </c:spPr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972285801784"/>
          <c:y val="0.133391787600361"/>
          <c:w val="0.722041957200186"/>
          <c:h val="0.56402050416469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4F81BD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IV training ratio'!$Q$6:$Q$23</c:f>
                <c:numCache>
                  <c:formatCode>General</c:formatCode>
                  <c:ptCount val="18"/>
                  <c:pt idx="0">
                    <c:v>0.000580862187513835</c:v>
                  </c:pt>
                  <c:pt idx="1">
                    <c:v>0.000340236354985856</c:v>
                  </c:pt>
                  <c:pt idx="2">
                    <c:v>0.000759497683056884</c:v>
                  </c:pt>
                  <c:pt idx="3">
                    <c:v>0.00176300447508585</c:v>
                  </c:pt>
                  <c:pt idx="4">
                    <c:v>0.000485160586063824</c:v>
                  </c:pt>
                  <c:pt idx="5">
                    <c:v>0.00212288001627043</c:v>
                  </c:pt>
                  <c:pt idx="6">
                    <c:v>0.000781915869014261</c:v>
                  </c:pt>
                  <c:pt idx="7">
                    <c:v>0.00033177181640261</c:v>
                  </c:pt>
                  <c:pt idx="8">
                    <c:v>0.00202758655237607</c:v>
                  </c:pt>
                </c:numCache>
              </c:numRef>
            </c:plus>
            <c:minus>
              <c:numRef>
                <c:f>'SIV training ratio'!$Q$6:$Q$23</c:f>
                <c:numCache>
                  <c:formatCode>General</c:formatCode>
                  <c:ptCount val="18"/>
                  <c:pt idx="0">
                    <c:v>0.000580862187513835</c:v>
                  </c:pt>
                  <c:pt idx="1">
                    <c:v>0.000340236354985856</c:v>
                  </c:pt>
                  <c:pt idx="2">
                    <c:v>0.000759497683056884</c:v>
                  </c:pt>
                  <c:pt idx="3">
                    <c:v>0.00176300447508585</c:v>
                  </c:pt>
                  <c:pt idx="4">
                    <c:v>0.000485160586063824</c:v>
                  </c:pt>
                  <c:pt idx="5">
                    <c:v>0.00212288001627043</c:v>
                  </c:pt>
                  <c:pt idx="6">
                    <c:v>0.000781915869014261</c:v>
                  </c:pt>
                  <c:pt idx="7">
                    <c:v>0.00033177181640261</c:v>
                  </c:pt>
                  <c:pt idx="8">
                    <c:v>0.00202758655237607</c:v>
                  </c:pt>
                </c:numCache>
              </c:numRef>
            </c:minus>
          </c:errBars>
          <c:cat>
            <c:numRef>
              <c:f>'SIV training ratio'!$O$6:$O$14</c:f>
              <c:numCache>
                <c:formatCode>General</c:formatCode>
                <c:ptCount val="9"/>
                <c:pt idx="0">
                  <c:v>2.0</c:v>
                </c:pt>
                <c:pt idx="1">
                  <c:v>3.0</c:v>
                </c:pt>
                <c:pt idx="2">
                  <c:v>4.0</c:v>
                </c:pt>
                <c:pt idx="3">
                  <c:v>5.0</c:v>
                </c:pt>
                <c:pt idx="4">
                  <c:v>6.0</c:v>
                </c:pt>
                <c:pt idx="5">
                  <c:v>7.0</c:v>
                </c:pt>
                <c:pt idx="6">
                  <c:v>8.0</c:v>
                </c:pt>
                <c:pt idx="7">
                  <c:v>9.0</c:v>
                </c:pt>
                <c:pt idx="8">
                  <c:v>10.0</c:v>
                </c:pt>
              </c:numCache>
            </c:numRef>
          </c:cat>
          <c:val>
            <c:numRef>
              <c:f>'SIV training ratio'!$P$6:$P$14</c:f>
              <c:numCache>
                <c:formatCode>General</c:formatCode>
                <c:ptCount val="9"/>
                <c:pt idx="0">
                  <c:v>0.779078503174714</c:v>
                </c:pt>
                <c:pt idx="1">
                  <c:v>0.779162748938131</c:v>
                </c:pt>
                <c:pt idx="2">
                  <c:v>0.780234353791609</c:v>
                </c:pt>
                <c:pt idx="3">
                  <c:v>0.778575413504399</c:v>
                </c:pt>
                <c:pt idx="4">
                  <c:v>0.781110552316273</c:v>
                </c:pt>
                <c:pt idx="5">
                  <c:v>0.779206148084747</c:v>
                </c:pt>
                <c:pt idx="6">
                  <c:v>0.781101617619236</c:v>
                </c:pt>
                <c:pt idx="7">
                  <c:v>0.780099872282122</c:v>
                </c:pt>
                <c:pt idx="8">
                  <c:v>0.77986159772378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D6B-C245-930F-F069460AA0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1250488"/>
        <c:axId val="-2144268312"/>
      </c:barChart>
      <c:catAx>
        <c:axId val="21212504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100" b="1" i="0" u="none" strike="noStrike" baseline="0" dirty="0">
                    <a:effectLst/>
                  </a:rPr>
                  <a:t>Minimum number of samples required to split a node 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.265711468572814"/>
              <c:y val="0.80127013921686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44268312"/>
        <c:crosses val="autoZero"/>
        <c:auto val="1"/>
        <c:lblAlgn val="ctr"/>
        <c:lblOffset val="100"/>
        <c:noMultiLvlLbl val="0"/>
      </c:catAx>
      <c:valAx>
        <c:axId val="-2144268312"/>
        <c:scaling>
          <c:orientation val="minMax"/>
          <c:min val="0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AUC-ROC</a:t>
                </a:r>
              </a:p>
            </c:rich>
          </c:tx>
          <c:layout>
            <c:manualLayout>
              <c:xMode val="edge"/>
              <c:yMode val="edge"/>
              <c:x val="0.00104795639651696"/>
              <c:y val="0.30450569694302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2121250488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4856686349956"/>
          <c:y val="0.133388851742352"/>
          <c:w val="0.713206625404071"/>
          <c:h val="0.56402339963318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4F81BD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IV training ratio'!$Z$7:$Z$11</c:f>
                <c:numCache>
                  <c:formatCode>General</c:formatCode>
                  <c:ptCount val="5"/>
                  <c:pt idx="0">
                    <c:v>0.00106133911288217</c:v>
                  </c:pt>
                  <c:pt idx="1">
                    <c:v>0.00103049513726567</c:v>
                  </c:pt>
                  <c:pt idx="2">
                    <c:v>0.000805296914124249</c:v>
                  </c:pt>
                  <c:pt idx="3">
                    <c:v>0.00214664546291015</c:v>
                  </c:pt>
                  <c:pt idx="4">
                    <c:v>0.0014260362829885</c:v>
                  </c:pt>
                </c:numCache>
              </c:numRef>
            </c:plus>
            <c:minus>
              <c:numRef>
                <c:f>'SIV training ratio'!$Z$7:$Z$11</c:f>
                <c:numCache>
                  <c:formatCode>General</c:formatCode>
                  <c:ptCount val="5"/>
                  <c:pt idx="0">
                    <c:v>0.00106133911288217</c:v>
                  </c:pt>
                  <c:pt idx="1">
                    <c:v>0.00103049513726567</c:v>
                  </c:pt>
                  <c:pt idx="2">
                    <c:v>0.000805296914124249</c:v>
                  </c:pt>
                  <c:pt idx="3">
                    <c:v>0.00214664546291015</c:v>
                  </c:pt>
                  <c:pt idx="4">
                    <c:v>0.0014260362829885</c:v>
                  </c:pt>
                </c:numCache>
              </c:numRef>
            </c:minus>
          </c:errBars>
          <c:cat>
            <c:numRef>
              <c:f>'SIV training ratio'!$X$7:$X$11</c:f>
              <c:numCache>
                <c:formatCode>General</c:formatCode>
                <c:ptCount val="5"/>
                <c:pt idx="0">
                  <c:v>25.0</c:v>
                </c:pt>
                <c:pt idx="1">
                  <c:v>50.0</c:v>
                </c:pt>
                <c:pt idx="2">
                  <c:v>100.0</c:v>
                </c:pt>
                <c:pt idx="3">
                  <c:v>200.0</c:v>
                </c:pt>
                <c:pt idx="4">
                  <c:v>300.0</c:v>
                </c:pt>
              </c:numCache>
            </c:numRef>
          </c:cat>
          <c:val>
            <c:numRef>
              <c:f>'SIV training ratio'!$Y$7:$Y$11</c:f>
              <c:numCache>
                <c:formatCode>General</c:formatCode>
                <c:ptCount val="5"/>
                <c:pt idx="0">
                  <c:v>0.780887614782842</c:v>
                </c:pt>
                <c:pt idx="1">
                  <c:v>0.789915065968867</c:v>
                </c:pt>
                <c:pt idx="2">
                  <c:v>0.794351244852388</c:v>
                </c:pt>
                <c:pt idx="3">
                  <c:v>0.796131616564213</c:v>
                </c:pt>
                <c:pt idx="4">
                  <c:v>0.79589649805596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C04-7A4B-98F9-11330E88E6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76772616"/>
        <c:axId val="-2127645640"/>
      </c:barChart>
      <c:catAx>
        <c:axId val="-207677261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100" b="1" i="0" u="none" strike="noStrike" baseline="0" dirty="0">
                    <a:effectLst/>
                  </a:rPr>
                  <a:t>Number of trees 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.416199347371253"/>
              <c:y val="0.8119063826702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27645640"/>
        <c:crosses val="autoZero"/>
        <c:auto val="1"/>
        <c:lblAlgn val="ctr"/>
        <c:lblOffset val="100"/>
        <c:noMultiLvlLbl val="0"/>
      </c:catAx>
      <c:valAx>
        <c:axId val="-2127645640"/>
        <c:scaling>
          <c:orientation val="minMax"/>
          <c:min val="0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AUC-ROC</a:t>
                </a:r>
              </a:p>
            </c:rich>
          </c:tx>
          <c:layout>
            <c:manualLayout>
              <c:xMode val="edge"/>
              <c:yMode val="edge"/>
              <c:x val="0.0175762186841432"/>
              <c:y val="0.3034809438263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076772616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2377015211666"/>
          <c:y val="0.150048480510184"/>
          <c:w val="0.689269626905687"/>
          <c:h val="0.514305980347498"/>
        </c:manualLayout>
      </c:layout>
      <c:barChart>
        <c:barDir val="col"/>
        <c:grouping val="clustered"/>
        <c:varyColors val="0"/>
        <c:ser>
          <c:idx val="1"/>
          <c:order val="0"/>
          <c:spPr>
            <a:solidFill>
              <a:schemeClr val="accent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IV training ratio'!$K$6:$K$24</c:f>
                <c:numCache>
                  <c:formatCode>General</c:formatCode>
                  <c:ptCount val="19"/>
                  <c:pt idx="0">
                    <c:v>0.0015858070254225</c:v>
                  </c:pt>
                  <c:pt idx="1">
                    <c:v>0.00216889470713339</c:v>
                  </c:pt>
                  <c:pt idx="2">
                    <c:v>0.000848352750580231</c:v>
                  </c:pt>
                  <c:pt idx="3">
                    <c:v>0.00231280295445319</c:v>
                  </c:pt>
                  <c:pt idx="4">
                    <c:v>0.00239061959539415</c:v>
                  </c:pt>
                  <c:pt idx="5">
                    <c:v>0.00108347165085461</c:v>
                  </c:pt>
                  <c:pt idx="6">
                    <c:v>0.000657102711252199</c:v>
                  </c:pt>
                  <c:pt idx="7">
                    <c:v>0.0025581592405031</c:v>
                  </c:pt>
                  <c:pt idx="8">
                    <c:v>0.00299322290167074</c:v>
                  </c:pt>
                  <c:pt idx="9">
                    <c:v>0.000685754753224337</c:v>
                  </c:pt>
                  <c:pt idx="10">
                    <c:v>0.00056130453085521</c:v>
                  </c:pt>
                  <c:pt idx="11">
                    <c:v>0.00137173668577056</c:v>
                  </c:pt>
                  <c:pt idx="12">
                    <c:v>0.00167880694981955</c:v>
                  </c:pt>
                  <c:pt idx="13">
                    <c:v>0.00227248291613488</c:v>
                  </c:pt>
                  <c:pt idx="14">
                    <c:v>0.00125683903009493</c:v>
                  </c:pt>
                  <c:pt idx="15">
                    <c:v>0.00120287290829429</c:v>
                  </c:pt>
                  <c:pt idx="16">
                    <c:v>0.00304843505989814</c:v>
                  </c:pt>
                  <c:pt idx="17">
                    <c:v>0.00155218792731418</c:v>
                  </c:pt>
                  <c:pt idx="18">
                    <c:v>0.00201433417729206</c:v>
                  </c:pt>
                </c:numCache>
              </c:numRef>
            </c:plus>
            <c:minus>
              <c:numRef>
                <c:f>'SIV training ratio'!$K$6:$K$24</c:f>
                <c:numCache>
                  <c:formatCode>General</c:formatCode>
                  <c:ptCount val="19"/>
                  <c:pt idx="0">
                    <c:v>0.0015858070254225</c:v>
                  </c:pt>
                  <c:pt idx="1">
                    <c:v>0.00216889470713339</c:v>
                  </c:pt>
                  <c:pt idx="2">
                    <c:v>0.000848352750580231</c:v>
                  </c:pt>
                  <c:pt idx="3">
                    <c:v>0.00231280295445319</c:v>
                  </c:pt>
                  <c:pt idx="4">
                    <c:v>0.00239061959539415</c:v>
                  </c:pt>
                  <c:pt idx="5">
                    <c:v>0.00108347165085461</c:v>
                  </c:pt>
                  <c:pt idx="6">
                    <c:v>0.000657102711252199</c:v>
                  </c:pt>
                  <c:pt idx="7">
                    <c:v>0.0025581592405031</c:v>
                  </c:pt>
                  <c:pt idx="8">
                    <c:v>0.00299322290167074</c:v>
                  </c:pt>
                  <c:pt idx="9">
                    <c:v>0.000685754753224337</c:v>
                  </c:pt>
                  <c:pt idx="10">
                    <c:v>0.00056130453085521</c:v>
                  </c:pt>
                  <c:pt idx="11">
                    <c:v>0.00137173668577056</c:v>
                  </c:pt>
                  <c:pt idx="12">
                    <c:v>0.00167880694981955</c:v>
                  </c:pt>
                  <c:pt idx="13">
                    <c:v>0.00227248291613488</c:v>
                  </c:pt>
                  <c:pt idx="14">
                    <c:v>0.00125683903009493</c:v>
                  </c:pt>
                  <c:pt idx="15">
                    <c:v>0.00120287290829429</c:v>
                  </c:pt>
                  <c:pt idx="16">
                    <c:v>0.00304843505989814</c:v>
                  </c:pt>
                  <c:pt idx="17">
                    <c:v>0.00155218792731418</c:v>
                  </c:pt>
                  <c:pt idx="18">
                    <c:v>0.00201433417729206</c:v>
                  </c:pt>
                </c:numCache>
              </c:numRef>
            </c:minus>
          </c:errBars>
          <c:cat>
            <c:numRef>
              <c:f>'SIV training ratio'!$I$8:$I$19</c:f>
              <c:numCache>
                <c:formatCode>General</c:formatCode>
                <c:ptCount val="12"/>
                <c:pt idx="0">
                  <c:v>4.0</c:v>
                </c:pt>
                <c:pt idx="1">
                  <c:v>5.0</c:v>
                </c:pt>
                <c:pt idx="2">
                  <c:v>6.0</c:v>
                </c:pt>
                <c:pt idx="3">
                  <c:v>7.0</c:v>
                </c:pt>
                <c:pt idx="4">
                  <c:v>8.0</c:v>
                </c:pt>
                <c:pt idx="5">
                  <c:v>9.0</c:v>
                </c:pt>
                <c:pt idx="6">
                  <c:v>10.0</c:v>
                </c:pt>
                <c:pt idx="7">
                  <c:v>11.0</c:v>
                </c:pt>
                <c:pt idx="8">
                  <c:v>12.0</c:v>
                </c:pt>
                <c:pt idx="9">
                  <c:v>13.0</c:v>
                </c:pt>
                <c:pt idx="10">
                  <c:v>14.0</c:v>
                </c:pt>
                <c:pt idx="11">
                  <c:v>15.0</c:v>
                </c:pt>
              </c:numCache>
            </c:numRef>
          </c:cat>
          <c:val>
            <c:numRef>
              <c:f>'SIV training ratio'!$J$8:$J$19</c:f>
              <c:numCache>
                <c:formatCode>General</c:formatCode>
                <c:ptCount val="12"/>
                <c:pt idx="0">
                  <c:v>0.792148013580246</c:v>
                </c:pt>
                <c:pt idx="1">
                  <c:v>0.790778024902175</c:v>
                </c:pt>
                <c:pt idx="2">
                  <c:v>0.793603864917112</c:v>
                </c:pt>
                <c:pt idx="3">
                  <c:v>0.793699988900557</c:v>
                </c:pt>
                <c:pt idx="4">
                  <c:v>0.792295361373272</c:v>
                </c:pt>
                <c:pt idx="5">
                  <c:v>0.791961366292873</c:v>
                </c:pt>
                <c:pt idx="6">
                  <c:v>0.793444654014096</c:v>
                </c:pt>
                <c:pt idx="7">
                  <c:v>0.794367062095964</c:v>
                </c:pt>
                <c:pt idx="8">
                  <c:v>0.792084781259772</c:v>
                </c:pt>
                <c:pt idx="9">
                  <c:v>0.792350003525558</c:v>
                </c:pt>
                <c:pt idx="10">
                  <c:v>0.793783710036017</c:v>
                </c:pt>
                <c:pt idx="11">
                  <c:v>0.79484632408885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815-0A46-84D8-603817FCA8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76209224"/>
        <c:axId val="-2076238072"/>
      </c:barChart>
      <c:catAx>
        <c:axId val="-20762092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100" b="1" i="0" u="none" strike="noStrike" baseline="0" dirty="0">
                    <a:effectLst/>
                  </a:rPr>
                  <a:t>Maximum number of features 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.273675005201365"/>
              <c:y val="0.8117059282878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076238072"/>
        <c:crosses val="autoZero"/>
        <c:auto val="1"/>
        <c:lblAlgn val="ctr"/>
        <c:lblOffset val="100"/>
        <c:noMultiLvlLbl val="0"/>
      </c:catAx>
      <c:valAx>
        <c:axId val="-2076238072"/>
        <c:scaling>
          <c:orientation val="minMax"/>
          <c:min val="0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AUC-ROC</a:t>
                </a:r>
              </a:p>
            </c:rich>
          </c:tx>
          <c:layout>
            <c:manualLayout>
              <c:xMode val="edge"/>
              <c:yMode val="edge"/>
              <c:x val="0.016291858299602"/>
              <c:y val="0.30361163532244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076209224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D5368F-1C20-2147-933B-25F31BF077BE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157C04-4056-9946-94CB-039BCFF2D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0229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E157C04-4056-9946-94CB-039BCFF2D2C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9510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720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563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275167"/>
            <a:ext cx="1543050" cy="585046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275167"/>
            <a:ext cx="4514850" cy="585046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848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880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0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237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030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21"/>
            <a:ext cx="303014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21"/>
            <a:ext cx="303133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985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079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916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9"/>
            <a:ext cx="2256235" cy="154940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342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352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074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52939" y="8036792"/>
            <a:ext cx="56895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Supplemental Figure S2 Parameter tuning for the </a:t>
            </a:r>
            <a:r>
              <a:rPr lang="en-US" sz="1200" i="1" dirty="0"/>
              <a:t>Setaria viridis </a:t>
            </a:r>
            <a:r>
              <a:rPr lang="en-US" sz="1200" dirty="0"/>
              <a:t>model based on cross-validation AUC-ROC. Error bars represent standard deviation, N=3. </a:t>
            </a: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2142764"/>
              </p:ext>
            </p:extLst>
          </p:nvPr>
        </p:nvGraphicFramePr>
        <p:xfrm>
          <a:off x="342900" y="2188599"/>
          <a:ext cx="2897703" cy="28259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9323485"/>
              </p:ext>
            </p:extLst>
          </p:nvPr>
        </p:nvGraphicFramePr>
        <p:xfrm>
          <a:off x="387059" y="4812190"/>
          <a:ext cx="2824545" cy="29812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8832878"/>
              </p:ext>
            </p:extLst>
          </p:nvPr>
        </p:nvGraphicFramePr>
        <p:xfrm>
          <a:off x="3386575" y="4812190"/>
          <a:ext cx="2890269" cy="2979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681465"/>
              </p:ext>
            </p:extLst>
          </p:nvPr>
        </p:nvGraphicFramePr>
        <p:xfrm>
          <a:off x="3386575" y="2109266"/>
          <a:ext cx="2955955" cy="3073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41784939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127</TotalTime>
  <Words>67</Words>
  <Application>Microsoft Macintosh PowerPoint</Application>
  <PresentationFormat>Letter Paper (8.5x11 in)</PresentationFormat>
  <Paragraphs>1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 Lin</dc:creator>
  <cp:lastModifiedBy>Fan Lin</cp:lastModifiedBy>
  <cp:revision>1272</cp:revision>
  <cp:lastPrinted>2020-01-29T19:46:17Z</cp:lastPrinted>
  <dcterms:created xsi:type="dcterms:W3CDTF">2018-04-05T21:34:21Z</dcterms:created>
  <dcterms:modified xsi:type="dcterms:W3CDTF">2020-02-03T04:15:56Z</dcterms:modified>
</cp:coreProperties>
</file>